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6" r:id="rId3"/>
    <p:sldId id="267" r:id="rId4"/>
    <p:sldId id="268" r:id="rId5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  <a:srgbClr val="008000"/>
    <a:srgbClr val="009999"/>
    <a:srgbClr val="FF99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678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02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69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71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6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62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307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3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84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67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99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67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013176" y="20047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3</a:t>
            </a:r>
            <a:endParaRPr lang="en-GB" sz="1200">
              <a:latin typeface="Century Schoolbook" panose="02040604050505020304" pitchFamily="18" charset="0"/>
            </a:endParaRPr>
          </a:p>
        </p:txBody>
      </p:sp>
      <p:sp>
        <p:nvSpPr>
          <p:cNvPr id="4" name="Rectangle 3"/>
          <p:cNvSpPr>
            <a:spLocks noChangeAspect="1"/>
          </p:cNvSpPr>
          <p:nvPr/>
        </p:nvSpPr>
        <p:spPr>
          <a:xfrm>
            <a:off x="548680" y="1064568"/>
            <a:ext cx="5878013" cy="89255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         </a:t>
            </a:r>
            <a:r>
              <a:rPr lang="en-GB" sz="70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|10       |20       |30       |40       |50       |60       |70       |80       |</a:t>
            </a: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90       |100</a:t>
            </a:r>
            <a:endParaRPr lang="en-GB" sz="700">
              <a:latin typeface="Courier New" panose="02070309020205020404" pitchFamily="49" charset="0"/>
              <a:ea typeface="Times New Roman"/>
              <a:cs typeface="Courier New" panose="02070309020205020404" pitchFamily="49" charset="0"/>
            </a:endParaRPr>
          </a:p>
          <a:p>
            <a:pPr>
              <a:spcAft>
                <a:spcPts val="600"/>
              </a:spcAft>
            </a:pP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GFYGDFQVEPVPDHVIIQSDSLLQLTMDKNSGGSVVSKSNYLFGYFNMKMKLISGNSAGTVTTFYIFSDEANHDEIDFEFLGNYSGDPYL</a:t>
            </a:r>
            <a:r>
              <a:rPr lang="en-GB" sz="700">
                <a:solidFill>
                  <a:prstClr val="black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LHTNIFASGV</a:t>
            </a:r>
            <a:endParaRPr lang="en-GB" sz="700">
              <a:latin typeface="Courier New" panose="02070309020205020404" pitchFamily="49" charset="0"/>
              <a:ea typeface="Times New Roman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70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         </a:t>
            </a: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|110      </a:t>
            </a:r>
            <a:r>
              <a:rPr lang="en-GB" sz="70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|120      |130      |140      |150      |160      |170      |</a:t>
            </a: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180</a:t>
            </a:r>
            <a:r>
              <a:rPr lang="en-GB" sz="700">
                <a:solidFill>
                  <a:prstClr val="black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 </a:t>
            </a:r>
            <a:r>
              <a:rPr lang="en-GB" sz="700" smtClean="0">
                <a:solidFill>
                  <a:prstClr val="black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     |</a:t>
            </a:r>
            <a:r>
              <a:rPr lang="en-GB" sz="700">
                <a:solidFill>
                  <a:prstClr val="black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190      |200</a:t>
            </a:r>
            <a:endParaRPr lang="en-GB" sz="700">
              <a:latin typeface="Courier New" panose="02070309020205020404" pitchFamily="49" charset="0"/>
              <a:ea typeface="Times New Roman"/>
              <a:cs typeface="Courier New" panose="02070309020205020404" pitchFamily="49" charset="0"/>
            </a:endParaRPr>
          </a:p>
          <a:p>
            <a:pPr>
              <a:spcAft>
                <a:spcPts val="600"/>
              </a:spcAft>
            </a:pP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GNREQQFFLWFDPTADFHDYTIIWNPQQILFLVDGRAVR</a:t>
            </a:r>
            <a:r>
              <a:rPr lang="en-GB" sz="700" b="1" smtClean="0">
                <a:solidFill>
                  <a:srgbClr val="33CC33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SFPNNEAIGVPYLK</a:t>
            </a: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SQWMNVHLSLWNGETWATLGGLRRIDW</a:t>
            </a:r>
            <a:r>
              <a:rPr lang="en-GB" sz="700" smtClean="0">
                <a:solidFill>
                  <a:prstClr val="black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NSAPFVASYSTFVGDSCFDS</a:t>
            </a:r>
            <a:endParaRPr lang="en-GB" sz="700">
              <a:latin typeface="Courier New" panose="02070309020205020404" pitchFamily="49" charset="0"/>
              <a:ea typeface="Times New Roman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         |</a:t>
            </a:r>
            <a:r>
              <a:rPr lang="en-GB" sz="70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210      |220      |230      |240      |250     |259</a:t>
            </a:r>
          </a:p>
          <a:p>
            <a:pPr>
              <a:spcAft>
                <a:spcPts val="600"/>
              </a:spcAft>
            </a:pP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ADSPCMASKWWNQAAYQSLSTSDASSIQWVR</a:t>
            </a:r>
            <a:r>
              <a:rPr lang="en-GB" sz="700" b="1" smtClean="0">
                <a:solidFill>
                  <a:srgbClr val="7030A0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ENYLKYDYCYDTK</a:t>
            </a:r>
            <a:r>
              <a:rPr lang="en-GB" sz="700" b="1" smtClean="0">
                <a:solidFill>
                  <a:srgbClr val="FF9900"/>
                </a:solidFill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LYPNGFPR</a:t>
            </a:r>
            <a:r>
              <a:rPr lang="en-GB" sz="700" smtClean="0">
                <a:latin typeface="Courier New" panose="02070309020205020404" pitchFamily="49" charset="0"/>
                <a:ea typeface="Times New Roman"/>
                <a:cs typeface="Courier New" panose="02070309020205020404" pitchFamily="49" charset="0"/>
              </a:rPr>
              <a:t>ECSNRGF</a:t>
            </a:r>
            <a:endParaRPr lang="en-GB" sz="70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>
            <a:spLocks noChangeAspect="1"/>
          </p:cNvSpPr>
          <p:nvPr/>
        </p:nvSpPr>
        <p:spPr>
          <a:xfrm>
            <a:off x="548680" y="818347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fHTG</a:t>
            </a:r>
            <a:r>
              <a:rPr lang="en-GB" sz="100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:</a:t>
            </a:r>
            <a:endParaRPr lang="en-GB" sz="100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1"/>
          <p:cNvSpPr txBox="1">
            <a:spLocks noChangeArrowheads="1"/>
          </p:cNvSpPr>
          <p:nvPr/>
        </p:nvSpPr>
        <p:spPr bwMode="auto">
          <a:xfrm>
            <a:off x="548680" y="338971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000" b="1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7" name="Rectangle 6"/>
          <p:cNvSpPr/>
          <p:nvPr/>
        </p:nvSpPr>
        <p:spPr>
          <a:xfrm>
            <a:off x="476671" y="2792760"/>
            <a:ext cx="5950021" cy="29700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900" b="1">
                <a:latin typeface="Century Schoolbook" panose="02040604050505020304" pitchFamily="18" charset="0"/>
                <a:ea typeface="Times New Roman" panose="02020603050405020304" pitchFamily="18" charset="0"/>
              </a:rPr>
              <a:t>Fig. S3.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Deduced sequence of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 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HTG, compared with several other family-GH16b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proteins.</a:t>
            </a:r>
            <a:r>
              <a:rPr lang="en-GB" sz="900" baseline="300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a</a:t>
            </a:r>
            <a:endParaRPr lang="en-GB" sz="900" baseline="3000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a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Sequence of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 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HTG; residues numbered contiguously after removal of the predicted signal peptide (which is MLGLVFGMLVIMLASPKLAMA).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The tryptic peptides noted in Fig. S2 are shown in colour.</a:t>
            </a:r>
            <a:endParaRPr lang="en-GB" sz="90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b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TG sequence, with gaps to maximise alignment with other family-GH16b sequences. The plant proteins are from Ef,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 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(present work); Ed,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 diffusu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and Eh,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 hyema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(hitherto non-annotated sequences from www.onekp.com); and At,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Arabidopsis thaliana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33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XTH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sequences</a:t>
            </a:r>
            <a:r>
              <a:rPr lang="en-GB" sz="900" baseline="300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b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)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.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The lichenase A sequence is from (A)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Bacillus subtilis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(accession no. AAB05759), lichenase B from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B. subtilis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(WP003244531), and lichenase C from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B. licheniformis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(P27051). All sequences shown are after removal of the predicted signal peptide. Arrows indicate key residues at which the thre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HTG sequences differ from all others (cf. main text Fig. 6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).</a:t>
            </a:r>
          </a:p>
          <a:p>
            <a:pPr>
              <a:spcAft>
                <a:spcPts val="600"/>
              </a:spcAft>
            </a:pP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a 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Strohmeier 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M </a:t>
            </a:r>
            <a:r>
              <a:rPr lang="en-GB" sz="8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t al.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(2004) Molecular modeling of family GH16 glycoside hydrolases: potential roles for xyloglucan transglucosylases/hydrolases in cell wall modification in the Poaceae. </a:t>
            </a:r>
            <a:r>
              <a:rPr lang="en-GB" sz="800" i="1">
                <a:latin typeface="Century Schoolbook" panose="02040604050505020304" pitchFamily="18" charset="0"/>
                <a:ea typeface="Times New Roman" panose="02020603050405020304" pitchFamily="18" charset="0"/>
              </a:rPr>
              <a:t>Protein Sci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800" b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13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: 3200–3213.</a:t>
            </a:r>
          </a:p>
          <a:p>
            <a:pPr>
              <a:spcAft>
                <a:spcPts val="600"/>
              </a:spcAft>
            </a:pP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b 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Yokoyama R, Nishitani K (2001) A comprehensive expression analysis of all members of a gene family encoding cell-wall enzymes allowed us to predict </a:t>
            </a:r>
            <a:r>
              <a:rPr lang="en-GB" sz="800" i="1">
                <a:latin typeface="Century Schoolbook" panose="02040604050505020304" pitchFamily="18" charset="0"/>
                <a:ea typeface="Times New Roman" panose="02020603050405020304" pitchFamily="18" charset="0"/>
              </a:rPr>
              <a:t>cis-regulatory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regions involved in cell-wall construction in specific organs of Arabidopsis. </a:t>
            </a:r>
            <a:r>
              <a:rPr lang="en-GB" sz="800" i="1">
                <a:latin typeface="Century Schoolbook" panose="02040604050505020304" pitchFamily="18" charset="0"/>
                <a:ea typeface="Times New Roman" panose="02020603050405020304" pitchFamily="18" charset="0"/>
              </a:rPr>
              <a:t>Plant Cell Physiol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800" b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42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: 1025–1033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.</a:t>
            </a:r>
          </a:p>
          <a:p>
            <a:pPr>
              <a:spcAft>
                <a:spcPts val="600"/>
              </a:spcAft>
            </a:pPr>
            <a:endParaRPr lang="en-GB" sz="800">
              <a:effectLst/>
              <a:latin typeface="Century Schoolbook" panose="020406040505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8266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>
            <a:grpSpLocks noChangeAspect="1"/>
          </p:cNvGrpSpPr>
          <p:nvPr/>
        </p:nvGrpSpPr>
        <p:grpSpPr>
          <a:xfrm>
            <a:off x="216000" y="1080000"/>
            <a:ext cx="6354499" cy="7200000"/>
            <a:chOff x="-182883" y="3216027"/>
            <a:chExt cx="3328301" cy="3771150"/>
          </a:xfrm>
        </p:grpSpPr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570"/>
            <a:stretch/>
          </p:blipFill>
          <p:spPr bwMode="auto">
            <a:xfrm>
              <a:off x="-182883" y="3298609"/>
              <a:ext cx="3328301" cy="36885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6" name="Straight Arrow Connector 15"/>
            <p:cNvCxnSpPr/>
            <p:nvPr/>
          </p:nvCxnSpPr>
          <p:spPr>
            <a:xfrm>
              <a:off x="1222358" y="3216027"/>
              <a:ext cx="0" cy="194361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1800268" y="3216027"/>
              <a:ext cx="0" cy="194361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Rectangle 24"/>
          <p:cNvSpPr/>
          <p:nvPr/>
        </p:nvSpPr>
        <p:spPr>
          <a:xfrm>
            <a:off x="671897" y="632520"/>
            <a:ext cx="5442703" cy="1984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800"/>
              </a:lnSpc>
              <a:spcAft>
                <a:spcPts val="0"/>
              </a:spcAft>
            </a:pPr>
            <a:r>
              <a:rPr lang="en-GB" altLang="en-US" sz="1000" u="sng">
                <a:latin typeface="Arial" pitchFamily="34" charset="0"/>
                <a:cs typeface="Arial" pitchFamily="34" charset="0"/>
              </a:rPr>
              <a:t>Colour coding</a:t>
            </a:r>
            <a:r>
              <a:rPr lang="en-GB" altLang="en-US" sz="1000">
                <a:latin typeface="Arial" pitchFamily="34" charset="0"/>
                <a:cs typeface="Arial" pitchFamily="34" charset="0"/>
              </a:rPr>
              <a:t>: </a:t>
            </a:r>
            <a:r>
              <a:rPr lang="en-GB" sz="1000" b="1" smtClean="0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p </a:t>
            </a:r>
            <a:r>
              <a:rPr lang="en-GB" sz="1000" b="1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&amp; Glu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Lys &amp; Arg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Hi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rp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8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yr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Cy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n (predicted </a:t>
            </a:r>
            <a:r>
              <a:rPr lang="en-GB" sz="1000" b="1" i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N</a:t>
            </a:r>
            <a:r>
              <a:rPr lang="en-GB" sz="1000" b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-glycosylated)</a:t>
            </a:r>
            <a:endParaRPr lang="en-GB" sz="1000" b="1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013176" y="200472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3 cont’d</a:t>
            </a:r>
            <a:endParaRPr lang="en-GB" sz="1200">
              <a:latin typeface="Century Schoolbook" panose="02040604050505020304" pitchFamily="18" charset="0"/>
            </a:endParaRPr>
          </a:p>
        </p:txBody>
      </p:sp>
      <p:sp>
        <p:nvSpPr>
          <p:cNvPr id="32" name="TextBox 1"/>
          <p:cNvSpPr txBox="1">
            <a:spLocks noChangeArrowheads="1"/>
          </p:cNvSpPr>
          <p:nvPr/>
        </p:nvSpPr>
        <p:spPr bwMode="auto">
          <a:xfrm>
            <a:off x="548680" y="338971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000" b="1">
                <a:latin typeface="Arial" pitchFamily="34" charset="0"/>
                <a:cs typeface="Arial" pitchFamily="34" charset="0"/>
              </a:rPr>
              <a:t>b</a:t>
            </a:r>
            <a:r>
              <a:rPr lang="en-GB" altLang="en-US" sz="1000" b="1" smtClean="0">
                <a:latin typeface="Arial" pitchFamily="34" charset="0"/>
                <a:cs typeface="Arial" pitchFamily="34" charset="0"/>
              </a:rPr>
              <a:t>, part 1</a:t>
            </a:r>
            <a:endParaRPr lang="en-GB" altLang="en-US" sz="1000" b="1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8691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6000" y="1237668"/>
            <a:ext cx="6116566" cy="7042332"/>
            <a:chOff x="2697437" y="3298609"/>
            <a:chExt cx="3203679" cy="3688568"/>
          </a:xfrm>
        </p:grpSpPr>
        <p:pic>
          <p:nvPicPr>
            <p:cNvPr id="2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5012"/>
            <a:stretch/>
          </p:blipFill>
          <p:spPr bwMode="auto">
            <a:xfrm>
              <a:off x="2697437" y="3298609"/>
              <a:ext cx="443531" cy="36885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30" r="31579"/>
            <a:stretch/>
          </p:blipFill>
          <p:spPr bwMode="auto">
            <a:xfrm>
              <a:off x="3145417" y="3298609"/>
              <a:ext cx="2755699" cy="36885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6" name="Rectangle 25"/>
          <p:cNvSpPr/>
          <p:nvPr/>
        </p:nvSpPr>
        <p:spPr>
          <a:xfrm>
            <a:off x="671897" y="632520"/>
            <a:ext cx="5442703" cy="1984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800"/>
              </a:lnSpc>
              <a:spcAft>
                <a:spcPts val="0"/>
              </a:spcAft>
            </a:pPr>
            <a:r>
              <a:rPr lang="en-GB" altLang="en-US" sz="1000" u="sng">
                <a:latin typeface="Arial" pitchFamily="34" charset="0"/>
                <a:cs typeface="Arial" pitchFamily="34" charset="0"/>
              </a:rPr>
              <a:t>Colour coding</a:t>
            </a:r>
            <a:r>
              <a:rPr lang="en-GB" altLang="en-US" sz="1000">
                <a:latin typeface="Arial" pitchFamily="34" charset="0"/>
                <a:cs typeface="Arial" pitchFamily="34" charset="0"/>
              </a:rPr>
              <a:t>: </a:t>
            </a:r>
            <a:r>
              <a:rPr lang="en-GB" sz="1000" b="1" smtClean="0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p </a:t>
            </a:r>
            <a:r>
              <a:rPr lang="en-GB" sz="1000" b="1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&amp; Glu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Lys &amp; Arg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Hi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rp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8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yr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Cy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n (predicted </a:t>
            </a:r>
            <a:r>
              <a:rPr lang="en-GB" sz="1000" b="1" i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N</a:t>
            </a:r>
            <a:r>
              <a:rPr lang="en-GB" sz="1000" b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-glycosylated)</a:t>
            </a:r>
            <a:endParaRPr lang="en-GB" sz="1000" b="1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27" name="TextBox 1"/>
          <p:cNvSpPr txBox="1">
            <a:spLocks noChangeArrowheads="1"/>
          </p:cNvSpPr>
          <p:nvPr/>
        </p:nvSpPr>
        <p:spPr bwMode="auto">
          <a:xfrm>
            <a:off x="548680" y="338971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000" b="1">
                <a:latin typeface="Arial" pitchFamily="34" charset="0"/>
                <a:cs typeface="Arial" pitchFamily="34" charset="0"/>
              </a:rPr>
              <a:t>b</a:t>
            </a:r>
            <a:r>
              <a:rPr lang="en-GB" altLang="en-US" sz="1000" b="1" smtClean="0">
                <a:latin typeface="Arial" pitchFamily="34" charset="0"/>
                <a:cs typeface="Arial" pitchFamily="34" charset="0"/>
              </a:rPr>
              <a:t>, part 2</a:t>
            </a:r>
            <a:endParaRPr lang="en-GB" altLang="en-US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013176" y="200472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3 cont’d</a:t>
            </a:r>
            <a:endParaRPr lang="en-GB" sz="1200">
              <a:latin typeface="Century Schoolbook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02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16000" y="1080000"/>
            <a:ext cx="6253452" cy="7200000"/>
            <a:chOff x="5433741" y="3216027"/>
            <a:chExt cx="3275376" cy="3771150"/>
          </a:xfrm>
        </p:grpSpPr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21"/>
            <a:stretch/>
          </p:blipFill>
          <p:spPr bwMode="auto">
            <a:xfrm>
              <a:off x="5901117" y="3298609"/>
              <a:ext cx="2808000" cy="36885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8" name="Straight Arrow Connector 17"/>
            <p:cNvCxnSpPr/>
            <p:nvPr/>
          </p:nvCxnSpPr>
          <p:spPr>
            <a:xfrm>
              <a:off x="7378009" y="3216027"/>
              <a:ext cx="0" cy="194361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5012"/>
            <a:stretch/>
          </p:blipFill>
          <p:spPr bwMode="auto">
            <a:xfrm>
              <a:off x="5433741" y="3298609"/>
              <a:ext cx="443531" cy="36885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6" name="Rectangle 25"/>
          <p:cNvSpPr/>
          <p:nvPr/>
        </p:nvSpPr>
        <p:spPr>
          <a:xfrm>
            <a:off x="671897" y="632520"/>
            <a:ext cx="5442703" cy="1984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800"/>
              </a:lnSpc>
              <a:spcAft>
                <a:spcPts val="0"/>
              </a:spcAft>
            </a:pPr>
            <a:r>
              <a:rPr lang="en-GB" altLang="en-US" sz="1000" u="sng">
                <a:latin typeface="Arial" pitchFamily="34" charset="0"/>
                <a:cs typeface="Arial" pitchFamily="34" charset="0"/>
              </a:rPr>
              <a:t>Colour coding</a:t>
            </a:r>
            <a:r>
              <a:rPr lang="en-GB" altLang="en-US" sz="1000">
                <a:latin typeface="Arial" pitchFamily="34" charset="0"/>
                <a:cs typeface="Arial" pitchFamily="34" charset="0"/>
              </a:rPr>
              <a:t>: </a:t>
            </a:r>
            <a:r>
              <a:rPr lang="en-GB" sz="1000" b="1" smtClean="0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p </a:t>
            </a:r>
            <a:r>
              <a:rPr lang="en-GB" sz="1000" b="1">
                <a:highlight>
                  <a:srgbClr val="FF0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&amp; Glu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Lys &amp; Arg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Hi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rp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0080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Tyr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FF00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Cys</a:t>
            </a:r>
            <a:r>
              <a:rPr lang="en-GB" sz="1000" b="1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, </a:t>
            </a:r>
            <a:r>
              <a:rPr lang="en-GB" sz="1000" b="1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sn (predicted </a:t>
            </a:r>
            <a:r>
              <a:rPr lang="en-GB" sz="1000" b="1" i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N</a:t>
            </a:r>
            <a:r>
              <a:rPr lang="en-GB" sz="1000" b="1" smtClean="0">
                <a:highlight>
                  <a:srgbClr val="FF00FF"/>
                </a:highlight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-glycosylated)</a:t>
            </a:r>
            <a:endParaRPr lang="en-GB" sz="1000" b="1"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27" name="TextBox 1"/>
          <p:cNvSpPr txBox="1">
            <a:spLocks noChangeArrowheads="1"/>
          </p:cNvSpPr>
          <p:nvPr/>
        </p:nvSpPr>
        <p:spPr bwMode="auto">
          <a:xfrm>
            <a:off x="548680" y="338971"/>
            <a:ext cx="68159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000" b="1">
                <a:latin typeface="Arial" pitchFamily="34" charset="0"/>
                <a:cs typeface="Arial" pitchFamily="34" charset="0"/>
              </a:rPr>
              <a:t>b</a:t>
            </a:r>
            <a:r>
              <a:rPr lang="en-GB" altLang="en-US" sz="1000" b="1" smtClean="0">
                <a:latin typeface="Arial" pitchFamily="34" charset="0"/>
                <a:cs typeface="Arial" pitchFamily="34" charset="0"/>
              </a:rPr>
              <a:t>, part 3</a:t>
            </a:r>
            <a:endParaRPr lang="en-GB" altLang="en-US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013176" y="200472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3 cont’d</a:t>
            </a:r>
            <a:endParaRPr lang="en-GB" sz="1200">
              <a:latin typeface="Century Schoolbook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02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427</Words>
  <Application>Microsoft Office PowerPoint</Application>
  <PresentationFormat>A4 Paper (210x297 mm)</PresentationFormat>
  <Paragraphs>23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Steve Fry</cp:lastModifiedBy>
  <cp:revision>95</cp:revision>
  <cp:lastPrinted>2015-03-02T19:14:39Z</cp:lastPrinted>
  <dcterms:created xsi:type="dcterms:W3CDTF">2014-10-24T13:36:09Z</dcterms:created>
  <dcterms:modified xsi:type="dcterms:W3CDTF">2015-07-12T20:26:21Z</dcterms:modified>
</cp:coreProperties>
</file>